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361" r:id="rId2"/>
    <p:sldId id="362" r:id="rId3"/>
    <p:sldId id="363" r:id="rId4"/>
    <p:sldId id="359" r:id="rId5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3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6C7"/>
    <a:srgbClr val="E4392E"/>
    <a:srgbClr val="3979F2"/>
    <a:srgbClr val="FF9933"/>
    <a:srgbClr val="D80CB1"/>
    <a:srgbClr val="F6C8D1"/>
    <a:srgbClr val="7F6485"/>
    <a:srgbClr val="8E5B22"/>
    <a:srgbClr val="DBFBD1"/>
    <a:srgbClr val="D8DC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2" autoAdjust="0"/>
    <p:restoredTop sz="95594" autoAdjust="0"/>
  </p:normalViewPr>
  <p:slideViewPr>
    <p:cSldViewPr snapToGrid="0">
      <p:cViewPr varScale="1">
        <p:scale>
          <a:sx n="114" d="100"/>
          <a:sy n="114" d="100"/>
        </p:scale>
        <p:origin x="-360" y="-108"/>
      </p:cViewPr>
      <p:guideLst>
        <p:guide orient="horz" pos="2160"/>
        <p:guide pos="383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EF201F-522B-48CE-A2A8-1705443DA50C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4FF4A3-BEFA-4312-B8F8-4768DEE0E7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5858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2/1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6.tiff"/><Relationship Id="rId18" Type="http://schemas.openxmlformats.org/officeDocument/2006/relationships/image" Target="../media/image21.tiff"/><Relationship Id="rId3" Type="http://schemas.openxmlformats.org/officeDocument/2006/relationships/image" Target="../media/image6.tiff"/><Relationship Id="rId21" Type="http://schemas.openxmlformats.org/officeDocument/2006/relationships/image" Target="../media/image24.tiff"/><Relationship Id="rId7" Type="http://schemas.openxmlformats.org/officeDocument/2006/relationships/image" Target="../media/image10.tiff"/><Relationship Id="rId12" Type="http://schemas.openxmlformats.org/officeDocument/2006/relationships/image" Target="../media/image15.tiff"/><Relationship Id="rId17" Type="http://schemas.openxmlformats.org/officeDocument/2006/relationships/image" Target="../media/image20.tiff"/><Relationship Id="rId2" Type="http://schemas.openxmlformats.org/officeDocument/2006/relationships/image" Target="../media/image5.tiff"/><Relationship Id="rId16" Type="http://schemas.openxmlformats.org/officeDocument/2006/relationships/image" Target="../media/image19.tiff"/><Relationship Id="rId20" Type="http://schemas.openxmlformats.org/officeDocument/2006/relationships/image" Target="../media/image2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11" Type="http://schemas.openxmlformats.org/officeDocument/2006/relationships/image" Target="../media/image14.tiff"/><Relationship Id="rId5" Type="http://schemas.openxmlformats.org/officeDocument/2006/relationships/image" Target="../media/image8.tiff"/><Relationship Id="rId15" Type="http://schemas.openxmlformats.org/officeDocument/2006/relationships/image" Target="../media/image18.tiff"/><Relationship Id="rId23" Type="http://schemas.openxmlformats.org/officeDocument/2006/relationships/image" Target="../media/image26.tiff"/><Relationship Id="rId10" Type="http://schemas.openxmlformats.org/officeDocument/2006/relationships/image" Target="../media/image13.tiff"/><Relationship Id="rId19" Type="http://schemas.openxmlformats.org/officeDocument/2006/relationships/image" Target="../media/image22.tiff"/><Relationship Id="rId4" Type="http://schemas.openxmlformats.org/officeDocument/2006/relationships/image" Target="../media/image7.tiff"/><Relationship Id="rId9" Type="http://schemas.openxmlformats.org/officeDocument/2006/relationships/image" Target="../media/image12.tiff"/><Relationship Id="rId14" Type="http://schemas.openxmlformats.org/officeDocument/2006/relationships/image" Target="../media/image17.tiff"/><Relationship Id="rId22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2">
            <a:extLst>
              <a:ext uri="{FF2B5EF4-FFF2-40B4-BE49-F238E27FC236}">
                <a16:creationId xmlns:a16="http://schemas.microsoft.com/office/drawing/2014/main" xmlns="" id="{447733A8-E6B5-C4A8-7F8D-6533CF2A14CC}"/>
              </a:ext>
            </a:extLst>
          </p:cNvPr>
          <p:cNvSpPr txBox="1"/>
          <p:nvPr/>
        </p:nvSpPr>
        <p:spPr>
          <a:xfrm>
            <a:off x="1057986" y="5131835"/>
            <a:ext cx="9965147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 The detailed category cluster of secondary metabolism related DEGs by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MapMa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zh-CN" sz="1400" kern="100" dirty="0">
              <a:effectLst/>
              <a:latin typeface="Arial" pitchFamily="34" charset="0"/>
              <a:ea typeface="等线" panose="02010600030101010101" pitchFamily="2" charset="-122"/>
              <a:cs typeface="Arial" pitchFamily="34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xmlns="" id="{30B13373-93EB-E4A1-80B7-78FE426242D1}"/>
              </a:ext>
            </a:extLst>
          </p:cNvPr>
          <p:cNvGrpSpPr/>
          <p:nvPr/>
        </p:nvGrpSpPr>
        <p:grpSpPr>
          <a:xfrm>
            <a:off x="2600801" y="501703"/>
            <a:ext cx="6204028" cy="4444278"/>
            <a:chOff x="2600801" y="501703"/>
            <a:chExt cx="6204028" cy="4444278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5" r="24360"/>
            <a:stretch>
              <a:fillRect/>
            </a:stretch>
          </p:blipFill>
          <p:spPr>
            <a:xfrm>
              <a:off x="2600801" y="501703"/>
              <a:ext cx="6120663" cy="4444278"/>
            </a:xfrm>
            <a:prstGeom prst="rect">
              <a:avLst/>
            </a:prstGeom>
          </p:spPr>
        </p:pic>
        <p:sp>
          <p:nvSpPr>
            <p:cNvPr id="2" name="矩形 1">
              <a:extLst>
                <a:ext uri="{FF2B5EF4-FFF2-40B4-BE49-F238E27FC236}">
                  <a16:creationId xmlns:a16="http://schemas.microsoft.com/office/drawing/2014/main" xmlns="" id="{AEE7DB59-703B-F820-FB8F-B1A225D697CD}"/>
                </a:ext>
              </a:extLst>
            </p:cNvPr>
            <p:cNvSpPr/>
            <p:nvPr/>
          </p:nvSpPr>
          <p:spPr>
            <a:xfrm>
              <a:off x="8435198" y="685858"/>
              <a:ext cx="46800" cy="902333"/>
            </a:xfrm>
            <a:prstGeom prst="rect">
              <a:avLst/>
            </a:prstGeom>
            <a:gradFill>
              <a:gsLst>
                <a:gs pos="0">
                  <a:srgbClr val="0101AF"/>
                </a:gs>
                <a:gs pos="50000">
                  <a:schemeClr val="bg1"/>
                </a:gs>
                <a:gs pos="81050">
                  <a:srgbClr val="FF0000"/>
                </a:gs>
                <a:gs pos="100000">
                  <a:srgbClr val="A8000A"/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xmlns="" id="{18461502-C676-6BE4-604D-B066EFA7F951}"/>
                </a:ext>
              </a:extLst>
            </p:cNvPr>
            <p:cNvSpPr txBox="1"/>
            <p:nvPr/>
          </p:nvSpPr>
          <p:spPr>
            <a:xfrm>
              <a:off x="8288341" y="1618443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log2F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2">
            <a:extLst>
              <a:ext uri="{FF2B5EF4-FFF2-40B4-BE49-F238E27FC236}">
                <a16:creationId xmlns:a16="http://schemas.microsoft.com/office/drawing/2014/main" xmlns="" id="{447733A8-E6B5-C4A8-7F8D-6533CF2A14CC}"/>
              </a:ext>
            </a:extLst>
          </p:cNvPr>
          <p:cNvSpPr txBox="1"/>
          <p:nvPr/>
        </p:nvSpPr>
        <p:spPr>
          <a:xfrm>
            <a:off x="2342638" y="5677256"/>
            <a:ext cx="7218611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Carotenoids pathway with mapped DEGs. </a:t>
            </a:r>
            <a:endParaRPr lang="zh-CN" altLang="zh-CN" sz="1400" kern="100" dirty="0">
              <a:effectLst/>
              <a:latin typeface="Arial" pitchFamily="34" charset="0"/>
              <a:ea typeface="等线" panose="02010600030101010101" pitchFamily="2" charset="-122"/>
              <a:cs typeface="Arial" pitchFamily="34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xmlns="" id="{6984832C-83D3-4BC9-03A5-458147637051}"/>
              </a:ext>
            </a:extLst>
          </p:cNvPr>
          <p:cNvGrpSpPr/>
          <p:nvPr/>
        </p:nvGrpSpPr>
        <p:grpSpPr>
          <a:xfrm>
            <a:off x="3634078" y="374354"/>
            <a:ext cx="4755467" cy="5102783"/>
            <a:chOff x="3634078" y="374354"/>
            <a:chExt cx="4755467" cy="5102783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xmlns="" id="{82E977C2-E02A-B4F1-660A-0144BADE05D9}"/>
                </a:ext>
              </a:extLst>
            </p:cNvPr>
            <p:cNvGrpSpPr/>
            <p:nvPr/>
          </p:nvGrpSpPr>
          <p:grpSpPr>
            <a:xfrm>
              <a:off x="3634078" y="374354"/>
              <a:ext cx="4755467" cy="5102783"/>
              <a:chOff x="3634078" y="374354"/>
              <a:chExt cx="4755467" cy="5102783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34078" y="374354"/>
                <a:ext cx="4755467" cy="5102783"/>
              </a:xfrm>
              <a:prstGeom prst="rect">
                <a:avLst/>
              </a:prstGeom>
            </p:spPr>
          </p:pic>
          <p:sp>
            <p:nvSpPr>
              <p:cNvPr id="2" name="文本框 1">
                <a:extLst>
                  <a:ext uri="{FF2B5EF4-FFF2-40B4-BE49-F238E27FC236}">
                    <a16:creationId xmlns:a16="http://schemas.microsoft.com/office/drawing/2014/main" xmlns="" id="{CECB784B-20B5-749F-B21E-5DB436675DD7}"/>
                  </a:ext>
                </a:extLst>
              </p:cNvPr>
              <p:cNvSpPr txBox="1"/>
              <p:nvPr/>
            </p:nvSpPr>
            <p:spPr>
              <a:xfrm>
                <a:off x="6947814" y="1273141"/>
                <a:ext cx="5164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og2FC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矩形 6">
              <a:extLst>
                <a:ext uri="{FF2B5EF4-FFF2-40B4-BE49-F238E27FC236}">
                  <a16:creationId xmlns:a16="http://schemas.microsoft.com/office/drawing/2014/main" xmlns="" id="{047F179F-EEA1-3913-A552-9696255556C0}"/>
                </a:ext>
              </a:extLst>
            </p:cNvPr>
            <p:cNvSpPr>
              <a:spLocks/>
            </p:cNvSpPr>
            <p:nvPr/>
          </p:nvSpPr>
          <p:spPr>
            <a:xfrm>
              <a:off x="7097650" y="498326"/>
              <a:ext cx="36000" cy="721867"/>
            </a:xfrm>
            <a:prstGeom prst="rect">
              <a:avLst/>
            </a:prstGeom>
            <a:gradFill>
              <a:gsLst>
                <a:gs pos="0">
                  <a:srgbClr val="0101AF"/>
                </a:gs>
                <a:gs pos="50000">
                  <a:schemeClr val="bg1"/>
                </a:gs>
                <a:gs pos="81050">
                  <a:srgbClr val="FF0000"/>
                </a:gs>
                <a:gs pos="100000">
                  <a:srgbClr val="A8000A"/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4362CD73-ABDB-8613-87B6-47BB8DB9C442}"/>
              </a:ext>
            </a:extLst>
          </p:cNvPr>
          <p:cNvSpPr txBox="1"/>
          <p:nvPr/>
        </p:nvSpPr>
        <p:spPr>
          <a:xfrm>
            <a:off x="1849034" y="5112261"/>
            <a:ext cx="7392620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Photosynthesis pathway with mapped DEGs. </a:t>
            </a:r>
            <a:endParaRPr lang="zh-CN" altLang="zh-CN" sz="1400" kern="100" dirty="0">
              <a:effectLst/>
              <a:latin typeface="Arial" pitchFamily="34" charset="0"/>
              <a:ea typeface="等线" panose="02010600030101010101" pitchFamily="2" charset="-122"/>
              <a:cs typeface="Arial" pitchFamily="34" charset="0"/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xmlns="" id="{872630D6-E3C8-BA96-B64A-2AA950F493C8}"/>
              </a:ext>
            </a:extLst>
          </p:cNvPr>
          <p:cNvGrpSpPr/>
          <p:nvPr/>
        </p:nvGrpSpPr>
        <p:grpSpPr>
          <a:xfrm>
            <a:off x="2174895" y="859466"/>
            <a:ext cx="6248676" cy="3800644"/>
            <a:chOff x="2174895" y="859466"/>
            <a:chExt cx="6248676" cy="3800644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xmlns="" id="{13166C9A-6874-8AD5-00E9-415765FB837C}"/>
                </a:ext>
              </a:extLst>
            </p:cNvPr>
            <p:cNvGrpSpPr/>
            <p:nvPr/>
          </p:nvGrpSpPr>
          <p:grpSpPr>
            <a:xfrm>
              <a:off x="2174895" y="859466"/>
              <a:ext cx="6248676" cy="3800644"/>
              <a:chOff x="2174895" y="859466"/>
              <a:chExt cx="6248676" cy="3800644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7876"/>
              <a:stretch/>
            </p:blipFill>
            <p:spPr bwMode="auto">
              <a:xfrm>
                <a:off x="2174895" y="859466"/>
                <a:ext cx="6105503" cy="38006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" name="文本框 1">
                <a:extLst>
                  <a:ext uri="{FF2B5EF4-FFF2-40B4-BE49-F238E27FC236}">
                    <a16:creationId xmlns:a16="http://schemas.microsoft.com/office/drawing/2014/main" xmlns="" id="{705CE10E-BB81-5DEE-54D5-8AB0862FCD22}"/>
                  </a:ext>
                </a:extLst>
              </p:cNvPr>
              <p:cNvSpPr txBox="1"/>
              <p:nvPr/>
            </p:nvSpPr>
            <p:spPr>
              <a:xfrm>
                <a:off x="7907083" y="1714173"/>
                <a:ext cx="5164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og2FC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xmlns="" id="{24FE9B42-23D2-B2FB-AE57-B7C3C75EE0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623112" y="859466"/>
                <a:ext cx="1104957" cy="584230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xmlns="" id="{B6ED9567-8831-C017-DE20-06D6527F16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23242" y="1286820"/>
                <a:ext cx="1104957" cy="584230"/>
              </a:xfrm>
              <a:prstGeom prst="rect">
                <a:avLst/>
              </a:prstGeom>
            </p:spPr>
          </p:pic>
        </p:grp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xmlns="" id="{C3B88E32-0B4E-478A-9686-0A10E23BE60F}"/>
                </a:ext>
              </a:extLst>
            </p:cNvPr>
            <p:cNvSpPr>
              <a:spLocks/>
            </p:cNvSpPr>
            <p:nvPr/>
          </p:nvSpPr>
          <p:spPr>
            <a:xfrm>
              <a:off x="8082678" y="925886"/>
              <a:ext cx="36000" cy="721867"/>
            </a:xfrm>
            <a:prstGeom prst="rect">
              <a:avLst/>
            </a:prstGeom>
            <a:gradFill>
              <a:gsLst>
                <a:gs pos="0">
                  <a:srgbClr val="0101AF"/>
                </a:gs>
                <a:gs pos="50000">
                  <a:schemeClr val="bg1"/>
                </a:gs>
                <a:gs pos="81050">
                  <a:srgbClr val="FF0000"/>
                </a:gs>
                <a:gs pos="100000">
                  <a:srgbClr val="A8000A"/>
                </a:gs>
              </a:gsLst>
              <a:lin ang="5400000" scaled="1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9906419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xmlns="" id="{A719F603-0106-FA7B-E09E-EB6355128317}"/>
              </a:ext>
            </a:extLst>
          </p:cNvPr>
          <p:cNvGrpSpPr/>
          <p:nvPr/>
        </p:nvGrpSpPr>
        <p:grpSpPr>
          <a:xfrm>
            <a:off x="2007104" y="160971"/>
            <a:ext cx="7850582" cy="5259708"/>
            <a:chOff x="2273804" y="799146"/>
            <a:chExt cx="7850582" cy="5259708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xmlns="" id="{2B58BE47-F2BC-BB26-5A3E-8CD2051157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3806" y="799146"/>
              <a:ext cx="1281649" cy="1152000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xmlns="" id="{08420F6C-4403-9CD6-9148-EF46249F09F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3806" y="2168382"/>
              <a:ext cx="1281648" cy="1152000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xmlns="" id="{2F243794-1A7F-179B-C361-90EC5648B47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3806" y="3537618"/>
              <a:ext cx="1281649" cy="1152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xmlns="" id="{E28EF71C-4119-6D16-21F3-269A62A5BFF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28959" y="799146"/>
              <a:ext cx="1281641" cy="1152000"/>
            </a:xfrm>
            <a:prstGeom prst="rect">
              <a:avLst/>
            </a:prstGeom>
          </p:spPr>
        </p:pic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xmlns="" id="{754A4070-35CB-AB36-FB51-8B398703885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28959" y="3537618"/>
              <a:ext cx="1281648" cy="11520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xmlns="" id="{598B7BC5-AE75-EDBA-19BB-E54AA9EEF12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42738" y="799146"/>
              <a:ext cx="1281648" cy="1152000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xmlns="" id="{5F9A6E1E-1513-AD85-9FE2-2F4D0DED9ED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42738" y="2168382"/>
              <a:ext cx="1281648" cy="1152000"/>
            </a:xfrm>
            <a:prstGeom prst="rect">
              <a:avLst/>
            </a:prstGeom>
          </p:spPr>
        </p:pic>
        <p:pic>
          <p:nvPicPr>
            <p:cNvPr id="60" name="图片 59">
              <a:extLst>
                <a:ext uri="{FF2B5EF4-FFF2-40B4-BE49-F238E27FC236}">
                  <a16:creationId xmlns:a16="http://schemas.microsoft.com/office/drawing/2014/main" xmlns="" id="{21CC4197-3809-33C5-CD8C-D0D5E4FB6DD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42738" y="3537618"/>
              <a:ext cx="1281648" cy="1152000"/>
            </a:xfrm>
            <a:prstGeom prst="rect">
              <a:avLst/>
            </a:prstGeom>
          </p:spPr>
        </p:pic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xmlns="" id="{B05896FF-ED86-C067-93BD-68C2889257E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3804" y="4906854"/>
              <a:ext cx="1281651" cy="1152000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xmlns="" id="{EC15E87A-D904-27A0-916F-8E8E50E564C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7597" y="799146"/>
              <a:ext cx="1281648" cy="1152000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xmlns="" id="{415D47C1-BB37-0BF0-5E9D-41F2F61FF44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7597" y="3537618"/>
              <a:ext cx="1281648" cy="1152000"/>
            </a:xfrm>
            <a:prstGeom prst="rect">
              <a:avLst/>
            </a:prstGeom>
          </p:spPr>
        </p:pic>
        <p:pic>
          <p:nvPicPr>
            <p:cNvPr id="64" name="图片 63">
              <a:extLst>
                <a:ext uri="{FF2B5EF4-FFF2-40B4-BE49-F238E27FC236}">
                  <a16:creationId xmlns:a16="http://schemas.microsoft.com/office/drawing/2014/main" xmlns="" id="{9DDAD24F-B8EE-E40C-D36B-0327F06610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7595" y="4906854"/>
              <a:ext cx="1281648" cy="11520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xmlns="" id="{AB815F3B-0DD4-7EA9-0544-8FED24E155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01385" y="799146"/>
              <a:ext cx="1281648" cy="115200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xmlns="" id="{CFD90EE7-EE9C-03DF-E0D5-1FC7621981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01385" y="2168382"/>
              <a:ext cx="1281648" cy="1152000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xmlns="" id="{98567098-F066-0072-7BA5-A627176FAF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01385" y="3537618"/>
              <a:ext cx="1281648" cy="1152000"/>
            </a:xfrm>
            <a:prstGeom prst="rect">
              <a:avLst/>
            </a:prstGeom>
          </p:spPr>
        </p:pic>
        <p:pic>
          <p:nvPicPr>
            <p:cNvPr id="66" name="图片 65">
              <a:extLst>
                <a:ext uri="{FF2B5EF4-FFF2-40B4-BE49-F238E27FC236}">
                  <a16:creationId xmlns:a16="http://schemas.microsoft.com/office/drawing/2014/main" xmlns="" id="{3024451A-1D0A-8A86-CC79-0D29D45C147B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01383" y="4906854"/>
              <a:ext cx="1281648" cy="1152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xmlns="" id="{79EA6DD5-EBA7-80A0-73A7-D8A8946BA7E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5172" y="799146"/>
              <a:ext cx="1281649" cy="1152000"/>
            </a:xfrm>
            <a:prstGeom prst="rect">
              <a:avLst/>
            </a:prstGeom>
          </p:spPr>
        </p:pic>
        <p:pic>
          <p:nvPicPr>
            <p:cNvPr id="55" name="图片 54">
              <a:extLst>
                <a:ext uri="{FF2B5EF4-FFF2-40B4-BE49-F238E27FC236}">
                  <a16:creationId xmlns:a16="http://schemas.microsoft.com/office/drawing/2014/main" xmlns="" id="{EF9798A5-41AE-9A2A-67B6-22D02285FD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5172" y="3537618"/>
              <a:ext cx="1281648" cy="1152000"/>
            </a:xfrm>
            <a:prstGeom prst="rect">
              <a:avLst/>
            </a:prstGeom>
          </p:spPr>
        </p:pic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xmlns="" id="{229B4C73-68B2-0D17-F769-9B3D1151AF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5170" y="4906854"/>
              <a:ext cx="1281650" cy="1152000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xmlns="" id="{B9A722C1-E4B7-B7D7-0DA5-BE04190B9C98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5163" y="2168382"/>
              <a:ext cx="1281644" cy="115200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xmlns="" id="{5E3DE2AE-0317-202D-0A2D-C598DDC62595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5454" y="2168382"/>
              <a:ext cx="1281644" cy="1152000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xmlns="" id="{457E2A73-B569-AFE4-7EFB-7868C0ACA2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28937" y="2168382"/>
              <a:ext cx="1281644" cy="1152000"/>
            </a:xfrm>
            <a:prstGeom prst="rect">
              <a:avLst/>
            </a:prstGeom>
          </p:spPr>
        </p:pic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A66DBA4D-2786-BA8C-7434-8F69E5660A5F}"/>
              </a:ext>
            </a:extLst>
          </p:cNvPr>
          <p:cNvSpPr txBox="1"/>
          <p:nvPr/>
        </p:nvSpPr>
        <p:spPr>
          <a:xfrm>
            <a:off x="302004" y="5512952"/>
            <a:ext cx="1109863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Expression analysis of Calcium ion-related genes. Leaves of </a:t>
            </a:r>
            <a:r>
              <a:rPr lang="en-US" altLang="zh-CN" sz="14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. japonica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were collected at SP, T15, and T30. RNAs were extracted and the expression of genes was measured by </a:t>
            </a:r>
            <a:r>
              <a:rPr lang="en-US" altLang="zh-CN" sz="14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qRT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PCR. Data are represented as the mean ± S.D. from 3 independent biological replicates. Means with the same letter were not significantly different among samples while different letters indicate that the change is significant according to Tukey's multiple comparison (</a:t>
            </a:r>
            <a:r>
              <a:rPr lang="en-US" altLang="zh-CN" sz="14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&lt; 0.05).</a:t>
            </a:r>
            <a:endParaRPr lang="zh-CN" altLang="zh-CN" sz="14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394762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jkzZThlMTJmODI1MmRmMjQzZWQ4ZjBjMmNkYmNkMjMifQ=="/>
  <p:tag name="KSO_WPP_MARK_KEY" val="4a1a2b8a-ab67-4489-a193-b8880ba52877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5</TotalTime>
  <Words>123</Words>
  <Application>Microsoft Office PowerPoint</Application>
  <PresentationFormat>自定义</PresentationFormat>
  <Paragraphs>7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梦</dc:creator>
  <cp:lastModifiedBy>DELL</cp:lastModifiedBy>
  <cp:revision>162</cp:revision>
  <dcterms:created xsi:type="dcterms:W3CDTF">2022-04-09T05:03:00Z</dcterms:created>
  <dcterms:modified xsi:type="dcterms:W3CDTF">2022-11-29T05:48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C85EC758326437CB2D57B554028B815</vt:lpwstr>
  </property>
  <property fmtid="{D5CDD505-2E9C-101B-9397-08002B2CF9AE}" pid="3" name="KSOProductBuildVer">
    <vt:lpwstr>2052-11.1.0.12358</vt:lpwstr>
  </property>
</Properties>
</file>